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2F485-DBE4-48F3-B735-1D4A8B7BAF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5DE3FA-BB83-476C-85F9-3311D800E9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D72E9-A5E7-4DF6-8804-5CD1F7950E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B4E5F-4D3F-4E2B-B3F2-80A184E31E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116E1-EDFE-4924-A848-3CC573D80D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0420A-EDC6-45BB-BE6C-B0DFEDFEF9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11D32-D2BF-4475-BFA3-E0D844AFDB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C19DA-5D3D-4061-989E-893B6C561E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DBE2C-7508-42F7-AFAD-60322E181E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C19E9-8CBB-4BBC-B0E6-1845840DE6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8E355-8BB6-4197-9A63-D29D0F3992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A3BBD-1130-4A80-9122-646835D7F3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88EF20-5E9B-487D-A9BF-C83024390BB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8320" y="6400800"/>
            <a:ext cx="148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ewis-Wambi et a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859080" y="6324480"/>
            <a:ext cx="155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data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1828800" y="609480"/>
            <a:ext cx="5237280" cy="4436280"/>
            <a:chOff x="1828800" y="609480"/>
            <a:chExt cx="5237280" cy="4436280"/>
          </a:xfrm>
        </p:grpSpPr>
        <p:graphicFrame>
          <p:nvGraphicFramePr>
            <p:cNvPr id="44" name=""/>
            <p:cNvGraphicFramePr/>
            <p:nvPr/>
          </p:nvGraphicFramePr>
          <p:xfrm>
            <a:off x="2036880" y="609480"/>
            <a:ext cx="5029200" cy="33433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036880" y="609480"/>
                      <a:ext cx="5029200" cy="3343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6" name=""/>
            <p:cNvSpPr/>
            <p:nvPr/>
          </p:nvSpPr>
          <p:spPr>
            <a:xfrm rot="16200000">
              <a:off x="2457720" y="377640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3011040" y="3820320"/>
              <a:ext cx="65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3652200" y="3701880"/>
              <a:ext cx="47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4325040" y="4100040"/>
              <a:ext cx="1432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-hydroxytamoxife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(4OH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4039200" y="3826440"/>
              <a:ext cx="73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2+B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5088960" y="3867120"/>
              <a:ext cx="823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OHT+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5571000" y="3921840"/>
              <a:ext cx="95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OHT+B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5997600" y="4047480"/>
              <a:ext cx="120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OHT+E2+B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1407960" y="2250000"/>
              <a:ext cx="111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DNA (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/wel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198600" y="16257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313160" y="28242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240080" y="2855880"/>
              <a:ext cx="1843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213080" y="28670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403880" y="2828880"/>
              <a:ext cx="1839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0T17:16:28Z</dcterms:created>
  <dc:creator>Information Science and Technology</dc:creator>
  <dc:description/>
  <dc:language>en-US</dc:language>
  <cp:lastModifiedBy>Information Science and Technology</cp:lastModifiedBy>
  <dcterms:modified xsi:type="dcterms:W3CDTF">2008-12-04T18:21:46Z</dcterms:modified>
  <cp:revision>9</cp:revision>
  <dc:subject/>
  <dc:title>Slide 1</dc:title>
</cp:coreProperties>
</file>